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1" r:id="rId3"/>
    <p:sldId id="260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C:\Users\&#33131;&#30221;&#20869;&#31185;\Desktop\nagaharu\ITP\ITP&#12288;case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&#33131;&#30221;&#20869;&#31185;\Desktop\nagaharu\ITP\ITP&#12288;case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6%20&#65369;itp\&#35542;&#25991;\&#32076;&#36942;&#3492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5915463020178653E-2"/>
          <c:y val="0.14736050029695247"/>
          <c:w val="0.90745989196792642"/>
          <c:h val="0.59394488792824374"/>
        </c:manualLayout>
      </c:layout>
      <c:lineChart>
        <c:grouping val="stacked"/>
        <c:varyColors val="0"/>
        <c:ser>
          <c:idx val="0"/>
          <c:order val="0"/>
          <c:tx>
            <c:strRef>
              <c:f>'[ITP　case.xlsx]Sheet1'!$B$3</c:f>
              <c:strCache>
                <c:ptCount val="1"/>
                <c:pt idx="0">
                  <c:v>Platelet count</c:v>
                </c:pt>
              </c:strCache>
            </c:strRef>
          </c:tx>
          <c:spPr>
            <a:ln w="63500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[ITP　case.xlsx]Sheet1'!$C$2:$AI$2</c:f>
              <c:strCache>
                <c:ptCount val="33"/>
                <c:pt idx="0">
                  <c:v>day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</c:strCache>
            </c:strRef>
          </c:cat>
          <c:val>
            <c:numRef>
              <c:f>'[ITP　case.xlsx]Sheet1'!$C$3:$AI$3</c:f>
              <c:numCache>
                <c:formatCode>General</c:formatCode>
                <c:ptCount val="33"/>
                <c:pt idx="0">
                  <c:v>0.30000000000000027</c:v>
                </c:pt>
                <c:pt idx="1">
                  <c:v>0</c:v>
                </c:pt>
                <c:pt idx="2">
                  <c:v>1.3</c:v>
                </c:pt>
                <c:pt idx="3">
                  <c:v>0.30000000000000027</c:v>
                </c:pt>
                <c:pt idx="4">
                  <c:v>0.2</c:v>
                </c:pt>
                <c:pt idx="5">
                  <c:v>0.1</c:v>
                </c:pt>
                <c:pt idx="6">
                  <c:v>0.8</c:v>
                </c:pt>
                <c:pt idx="7">
                  <c:v>1.4</c:v>
                </c:pt>
                <c:pt idx="8">
                  <c:v>0.1</c:v>
                </c:pt>
                <c:pt idx="9">
                  <c:v>0.30000000000000027</c:v>
                </c:pt>
                <c:pt idx="10">
                  <c:v>0.4</c:v>
                </c:pt>
                <c:pt idx="11">
                  <c:v>0.4</c:v>
                </c:pt>
                <c:pt idx="12">
                  <c:v>0.1</c:v>
                </c:pt>
                <c:pt idx="13">
                  <c:v>0.30000000000000027</c:v>
                </c:pt>
                <c:pt idx="14">
                  <c:v>0.60000000000000053</c:v>
                </c:pt>
                <c:pt idx="15">
                  <c:v>2.5</c:v>
                </c:pt>
                <c:pt idx="16">
                  <c:v>1.1000000000000001</c:v>
                </c:pt>
                <c:pt idx="17">
                  <c:v>3.4</c:v>
                </c:pt>
                <c:pt idx="18">
                  <c:v>2</c:v>
                </c:pt>
                <c:pt idx="19">
                  <c:v>2.2000000000000002</c:v>
                </c:pt>
                <c:pt idx="20">
                  <c:v>3.6</c:v>
                </c:pt>
                <c:pt idx="21">
                  <c:v>9.7000000000000011</c:v>
                </c:pt>
                <c:pt idx="22">
                  <c:v>15.4</c:v>
                </c:pt>
                <c:pt idx="23">
                  <c:v>24.2</c:v>
                </c:pt>
                <c:pt idx="24">
                  <c:v>37.4</c:v>
                </c:pt>
                <c:pt idx="25">
                  <c:v>51.1</c:v>
                </c:pt>
                <c:pt idx="26">
                  <c:v>78.7</c:v>
                </c:pt>
                <c:pt idx="27">
                  <c:v>96</c:v>
                </c:pt>
                <c:pt idx="28">
                  <c:v>97.5</c:v>
                </c:pt>
                <c:pt idx="29">
                  <c:v>97.1</c:v>
                </c:pt>
                <c:pt idx="30">
                  <c:v>78.400000000000006</c:v>
                </c:pt>
                <c:pt idx="31">
                  <c:v>65.5</c:v>
                </c:pt>
                <c:pt idx="32">
                  <c:v>33.80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C5F-4E00-A58E-54A734BEC2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25040896"/>
        <c:axId val="125112320"/>
      </c:lineChart>
      <c:catAx>
        <c:axId val="125040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crossAx val="125112320"/>
        <c:crosses val="autoZero"/>
        <c:auto val="1"/>
        <c:lblAlgn val="ctr"/>
        <c:lblOffset val="100"/>
        <c:tickLblSkip val="3"/>
        <c:noMultiLvlLbl val="1"/>
      </c:catAx>
      <c:valAx>
        <c:axId val="125112320"/>
        <c:scaling>
          <c:orientation val="minMax"/>
          <c:max val="100"/>
        </c:scaling>
        <c:delete val="1"/>
        <c:axPos val="l"/>
        <c:numFmt formatCode="General" sourceLinked="1"/>
        <c:majorTickMark val="none"/>
        <c:minorTickMark val="none"/>
        <c:tickLblPos val="nextTo"/>
        <c:crossAx val="12504089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zero"/>
    <c:showDLblsOverMax val="0"/>
  </c:chart>
  <c:txPr>
    <a:bodyPr/>
    <a:lstStyle/>
    <a:p>
      <a:pPr>
        <a:defRPr sz="2000" baseline="0">
          <a:solidFill>
            <a:schemeClr val="tx1"/>
          </a:solidFill>
          <a:latin typeface="Arial" pitchFamily="34" charset="0"/>
          <a:cs typeface="Arial" pitchFamily="34" charset="0"/>
        </a:defRPr>
      </a:pPr>
      <a:endParaRPr lang="ja-JP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4962249171038497E-2"/>
          <c:y val="8.2987684898579633E-2"/>
          <c:w val="0.89972445786696142"/>
          <c:h val="0.74213030864057683"/>
        </c:manualLayout>
      </c:layout>
      <c:lineChart>
        <c:grouping val="standard"/>
        <c:varyColors val="0"/>
        <c:ser>
          <c:idx val="0"/>
          <c:order val="0"/>
          <c:tx>
            <c:strRef>
              <c:f>'[ITP　case.xlsx]Sheet2'!$B$3</c:f>
              <c:strCache>
                <c:ptCount val="1"/>
                <c:pt idx="0">
                  <c:v>Platelet count</c:v>
                </c:pt>
              </c:strCache>
            </c:strRef>
          </c:tx>
          <c:spPr>
            <a:ln w="69850"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'[ITP　case.xlsx]Sheet2'!$C$2:$AJ$2</c:f>
              <c:strCache>
                <c:ptCount val="34"/>
                <c:pt idx="0">
                  <c:v>day1</c:v>
                </c:pt>
                <c:pt idx="1">
                  <c:v>2 </c:v>
                </c:pt>
                <c:pt idx="2">
                  <c:v>3 </c:v>
                </c:pt>
                <c:pt idx="3">
                  <c:v>4 </c:v>
                </c:pt>
                <c:pt idx="4">
                  <c:v>5 </c:v>
                </c:pt>
                <c:pt idx="5">
                  <c:v>6 </c:v>
                </c:pt>
                <c:pt idx="6">
                  <c:v>7 </c:v>
                </c:pt>
                <c:pt idx="7">
                  <c:v>8 </c:v>
                </c:pt>
                <c:pt idx="8">
                  <c:v>9 </c:v>
                </c:pt>
                <c:pt idx="9">
                  <c:v>10 </c:v>
                </c:pt>
                <c:pt idx="10">
                  <c:v>11 </c:v>
                </c:pt>
                <c:pt idx="11">
                  <c:v>12 </c:v>
                </c:pt>
                <c:pt idx="12">
                  <c:v>13 </c:v>
                </c:pt>
                <c:pt idx="13">
                  <c:v>14 </c:v>
                </c:pt>
                <c:pt idx="14">
                  <c:v>15 </c:v>
                </c:pt>
                <c:pt idx="15">
                  <c:v>16 </c:v>
                </c:pt>
                <c:pt idx="16">
                  <c:v>17 </c:v>
                </c:pt>
                <c:pt idx="17">
                  <c:v>18 </c:v>
                </c:pt>
                <c:pt idx="18">
                  <c:v>19 </c:v>
                </c:pt>
                <c:pt idx="19">
                  <c:v>20 </c:v>
                </c:pt>
                <c:pt idx="20">
                  <c:v>21 </c:v>
                </c:pt>
                <c:pt idx="21">
                  <c:v>22 </c:v>
                </c:pt>
                <c:pt idx="22">
                  <c:v>23 </c:v>
                </c:pt>
                <c:pt idx="23">
                  <c:v>24 </c:v>
                </c:pt>
                <c:pt idx="24">
                  <c:v>25 </c:v>
                </c:pt>
                <c:pt idx="25">
                  <c:v>26 </c:v>
                </c:pt>
                <c:pt idx="26">
                  <c:v>27 </c:v>
                </c:pt>
                <c:pt idx="27">
                  <c:v>28 </c:v>
                </c:pt>
                <c:pt idx="28">
                  <c:v>29 </c:v>
                </c:pt>
                <c:pt idx="29">
                  <c:v>30 </c:v>
                </c:pt>
                <c:pt idx="30">
                  <c:v>31 </c:v>
                </c:pt>
                <c:pt idx="31">
                  <c:v>32 </c:v>
                </c:pt>
                <c:pt idx="32">
                  <c:v>33 </c:v>
                </c:pt>
                <c:pt idx="33">
                  <c:v>34 </c:v>
                </c:pt>
              </c:strCache>
            </c:strRef>
          </c:cat>
          <c:val>
            <c:numRef>
              <c:f>'[ITP　case.xlsx]Sheet2'!$C$3:$AJ$3</c:f>
              <c:numCache>
                <c:formatCode>General</c:formatCode>
                <c:ptCount val="34"/>
                <c:pt idx="0">
                  <c:v>0.60000000000000053</c:v>
                </c:pt>
                <c:pt idx="1">
                  <c:v>0</c:v>
                </c:pt>
                <c:pt idx="2">
                  <c:v>0.1</c:v>
                </c:pt>
                <c:pt idx="3">
                  <c:v>0.1</c:v>
                </c:pt>
                <c:pt idx="4">
                  <c:v>0.70000000000000051</c:v>
                </c:pt>
                <c:pt idx="5">
                  <c:v>0.9</c:v>
                </c:pt>
                <c:pt idx="6">
                  <c:v>0.8</c:v>
                </c:pt>
                <c:pt idx="7">
                  <c:v>1.5</c:v>
                </c:pt>
                <c:pt idx="8">
                  <c:v>2.7</c:v>
                </c:pt>
                <c:pt idx="9">
                  <c:v>7.4</c:v>
                </c:pt>
                <c:pt idx="10">
                  <c:v>13.9</c:v>
                </c:pt>
                <c:pt idx="11">
                  <c:v>27.9</c:v>
                </c:pt>
                <c:pt idx="12">
                  <c:v>37.200000000000003</c:v>
                </c:pt>
                <c:pt idx="15">
                  <c:v>65.7</c:v>
                </c:pt>
                <c:pt idx="17">
                  <c:v>79.8</c:v>
                </c:pt>
                <c:pt idx="19">
                  <c:v>83.6</c:v>
                </c:pt>
                <c:pt idx="22">
                  <c:v>77.8</c:v>
                </c:pt>
                <c:pt idx="24">
                  <c:v>72.98</c:v>
                </c:pt>
                <c:pt idx="26">
                  <c:v>59.1</c:v>
                </c:pt>
                <c:pt idx="33">
                  <c:v>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5E0-4827-A0BB-F59EEBD669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18992896"/>
        <c:axId val="118994432"/>
      </c:lineChart>
      <c:catAx>
        <c:axId val="118992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crossAx val="118994432"/>
        <c:crosses val="autoZero"/>
        <c:auto val="1"/>
        <c:lblAlgn val="ctr"/>
        <c:lblOffset val="100"/>
        <c:tickLblSkip val="3"/>
        <c:noMultiLvlLbl val="0"/>
      </c:catAx>
      <c:valAx>
        <c:axId val="118994432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118992896"/>
        <c:crosses val="autoZero"/>
        <c:crossBetween val="between"/>
      </c:valAx>
    </c:plotArea>
    <c:plotVisOnly val="1"/>
    <c:dispBlanksAs val="span"/>
    <c:showDLblsOverMax val="0"/>
  </c:chart>
  <c:txPr>
    <a:bodyPr/>
    <a:lstStyle/>
    <a:p>
      <a:pPr>
        <a:defRPr sz="2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4076443569553804E-2"/>
          <c:y val="4.6770924467774859E-2"/>
          <c:w val="0.92619346019247595"/>
          <c:h val="0.69769048494735664"/>
        </c:manualLayout>
      </c:layout>
      <c:lineChart>
        <c:grouping val="standard"/>
        <c:varyColors val="0"/>
        <c:ser>
          <c:idx val="0"/>
          <c:order val="0"/>
          <c:tx>
            <c:strRef>
              <c:f>case3!$A$3</c:f>
              <c:strCache>
                <c:ptCount val="1"/>
                <c:pt idx="0">
                  <c:v>Plt</c:v>
                </c:pt>
              </c:strCache>
            </c:strRef>
          </c:tx>
          <c:spPr>
            <a:ln w="63500">
              <a:solidFill>
                <a:schemeClr val="tx1"/>
              </a:solidFill>
            </a:ln>
          </c:spPr>
          <c:marker>
            <c:symbol val="none"/>
          </c:marker>
          <c:val>
            <c:numRef>
              <c:f>case3!$B$4:$AD$4</c:f>
              <c:numCache>
                <c:formatCode>General</c:formatCode>
                <c:ptCount val="29"/>
                <c:pt idx="0">
                  <c:v>2.2000000000000002</c:v>
                </c:pt>
                <c:pt idx="1">
                  <c:v>1.2</c:v>
                </c:pt>
                <c:pt idx="2">
                  <c:v>0.2</c:v>
                </c:pt>
                <c:pt idx="3">
                  <c:v>0.2</c:v>
                </c:pt>
                <c:pt idx="4">
                  <c:v>0.5</c:v>
                </c:pt>
                <c:pt idx="5">
                  <c:v>0.8</c:v>
                </c:pt>
                <c:pt idx="6">
                  <c:v>2.5</c:v>
                </c:pt>
                <c:pt idx="7">
                  <c:v>4.4000000000000004</c:v>
                </c:pt>
                <c:pt idx="8">
                  <c:v>3.7</c:v>
                </c:pt>
                <c:pt idx="9">
                  <c:v>6</c:v>
                </c:pt>
                <c:pt idx="10">
                  <c:v>7.6</c:v>
                </c:pt>
                <c:pt idx="11">
                  <c:v>12.9</c:v>
                </c:pt>
                <c:pt idx="18">
                  <c:v>31.3</c:v>
                </c:pt>
                <c:pt idx="22">
                  <c:v>53.5</c:v>
                </c:pt>
                <c:pt idx="26">
                  <c:v>47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6B0-4763-8D8A-EE95D45E43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19122560"/>
        <c:axId val="119124352"/>
      </c:lineChart>
      <c:catAx>
        <c:axId val="11912256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2000"/>
            </a:pPr>
            <a:endParaRPr lang="ja-JP"/>
          </a:p>
        </c:txPr>
        <c:crossAx val="119124352"/>
        <c:crosses val="autoZero"/>
        <c:auto val="1"/>
        <c:lblAlgn val="ctr"/>
        <c:lblOffset val="100"/>
        <c:tickLblSkip val="3"/>
        <c:tickMarkSkip val="1"/>
        <c:noMultiLvlLbl val="0"/>
      </c:catAx>
      <c:valAx>
        <c:axId val="119124352"/>
        <c:scaling>
          <c:orientation val="minMax"/>
        </c:scaling>
        <c:delete val="1"/>
        <c:axPos val="l"/>
        <c:numFmt formatCode="General" sourceLinked="1"/>
        <c:majorTickMark val="out"/>
        <c:minorTickMark val="none"/>
        <c:tickLblPos val="nextTo"/>
        <c:crossAx val="119122560"/>
        <c:crosses val="autoZero"/>
        <c:crossBetween val="between"/>
      </c:valAx>
    </c:plotArea>
    <c:plotVisOnly val="1"/>
    <c:dispBlanksAs val="span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2308</cdr:x>
      <cdr:y>0.32862</cdr:y>
    </cdr:from>
    <cdr:to>
      <cdr:x>0.0988</cdr:x>
      <cdr:y>0.38516</cdr:y>
    </cdr:to>
    <cdr:sp macro="" textlink="">
      <cdr:nvSpPr>
        <cdr:cNvPr id="39" name="テキスト ボックス 38"/>
        <cdr:cNvSpPr txBox="1"/>
      </cdr:nvSpPr>
      <cdr:spPr>
        <a:xfrm xmlns:a="http://schemas.openxmlformats.org/drawingml/2006/main">
          <a:off x="238125" y="1771650"/>
          <a:ext cx="78105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 baseline="30000"/>
        </a:p>
      </cdr:txBody>
    </cdr:sp>
  </cdr:relSizeAnchor>
  <cdr:relSizeAnchor xmlns:cdr="http://schemas.openxmlformats.org/drawingml/2006/chartDrawing">
    <cdr:from>
      <cdr:x>0.52853</cdr:x>
      <cdr:y>0.03104</cdr:y>
    </cdr:from>
    <cdr:to>
      <cdr:x>0.81397</cdr:x>
      <cdr:y>0.08581</cdr:y>
    </cdr:to>
    <cdr:sp macro="" textlink="">
      <cdr:nvSpPr>
        <cdr:cNvPr id="18" name="テキスト ボックス 17"/>
        <cdr:cNvSpPr txBox="1"/>
      </cdr:nvSpPr>
      <cdr:spPr>
        <a:xfrm xmlns:a="http://schemas.openxmlformats.org/drawingml/2006/main">
          <a:off x="4896544" y="144016"/>
          <a:ext cx="2644466" cy="2541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>
            <a:solidFill>
              <a:schemeClr val="bg1"/>
            </a:solidFill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90FFAA-F18F-4EFC-B26D-45EC9167CC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6761657-E29E-4EB5-BA87-C102D270F3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A8A1A09-73A1-423D-A154-AE284B3F2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8EFCED-F34F-401E-9733-9F6E33DEA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B7D195-E52C-4285-A6FF-0BCD0B4050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0051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369787-AEEF-43C5-858B-80523CBAE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AEDE3ED-0393-41D2-AF49-ABE9A75378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6A0F6F-8B4E-4D70-B58E-75B79703C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688A59-15AD-4803-933C-831037D03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B7570B-0919-48FA-B011-317C0112B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253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A5BE5F2-A288-491E-AA8C-F7638B36D2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5D525D8-95D4-4A16-A207-6992DCBA2D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A76BE3-DAA4-432A-A624-360FFB670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74B14F-8ADF-49AA-83DE-CE162650D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C57A79-6BE4-4044-B773-A233D93C1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255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5A7D77-D394-4EDD-94A6-58B3FDDAA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CF83638-3894-4FCA-ABC8-702D452463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42ECDA-8B03-4678-9EFD-DDC1E28B5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29A001-706F-4756-9E70-96A89B923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731B154-A768-4FE7-BD7A-72B0AEC52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6682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BE21A6-0E6A-4DC8-91B6-5CB26240AA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119611B-4305-4282-B261-D6BC0AEC36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F831AA-B8B0-40CD-B10D-2E83D7EE6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D88E29-A6A1-411F-806A-511C80425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2A1BD5-7B1D-4AA3-8CEB-CF60B6837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552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5D13F8-98E7-46B2-8C19-0A0341EBA5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992D22D-C949-4D7B-8AEF-A9D6060F02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D409EFF-B105-4040-A168-B828E48BAA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5E0EA6-A030-46E4-A564-6598DA652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9FB6A00-695C-4BA2-B6BE-71B7A9569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450D1C-B005-45D2-90D2-77FA6B7B4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9626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37DA0C-568B-4EE4-BF73-8901181C37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7DF862C-CDC0-4A7E-AE72-D8E29356E7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38E7176-D4E3-404F-845B-B123B57FA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E1998E7-55CA-4675-B85E-B58AB67098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3B06DF2-F870-4D7B-BB9E-B3D50BA704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10474DC-6DD5-4D59-9C9E-9983D679F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354B115-C2B3-4121-A0DB-73FCA1FF9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D134008-029A-4ADA-8CA0-65C326E59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559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397232-BA35-4639-B2FE-CBB5637EE1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9D98184-18C9-4079-BDF1-6F7F477D1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EC4B12E-423B-44CB-821B-3F0E0D2D1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4EA8CF5-7EDA-4AAA-92A7-2E23657BD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295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2913EDC-6C49-40B1-836F-4D41205D7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480D986-1B52-4C43-B496-6A2842EBA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8E3748B-43BA-4027-B3B2-C9EBE5605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643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B59F3E-AE50-4CED-ADCE-91DE9A2CA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6CDE131-AD16-46D1-A554-7B92792801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C7DB85-2A8A-4431-A80B-142F15DDC0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86C666D-4CEC-4ADD-AB24-95997E1C3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E2886A1-72D2-4489-A329-99A989548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B1EAB61-1364-4E51-9C2E-DDE871809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662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1E8B13-0839-4434-B9F6-51866A31B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42D5DC3-E336-4DD2-A1ED-81F6D68AE2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83C0E42-273E-4E07-B7B6-4ABBB17930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BB87498-0657-4A9B-95B7-91313B1BE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C4F5B47-C9BB-479D-9C8F-16618E918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4B45D8D-E6FC-4A17-9A70-5F60C93BD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744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7DBA41A-56AD-4C49-A4C8-AA14D4474E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98D6368-8CBD-4420-8857-408954DEA7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18964CE-C5C4-415E-A50C-D224BEF842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9A52C8-3EFF-440E-AE67-DDA57F272D98}" type="datetimeFigureOut">
              <a:rPr kumimoji="1" lang="ja-JP" altLang="en-US" smtClean="0"/>
              <a:t>2019/5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555490-3E9E-4B26-86E2-827240492D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0F9D0B-64DC-49C9-9FB1-4AEA334258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4C416-4AB4-4A51-9F67-4E93270856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7455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 noChangeAspect="1"/>
          </p:cNvGraphicFramePr>
          <p:nvPr>
            <p:extLst/>
          </p:nvPr>
        </p:nvGraphicFramePr>
        <p:xfrm>
          <a:off x="1775520" y="1721082"/>
          <a:ext cx="8712968" cy="24279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下矢印 10"/>
          <p:cNvSpPr/>
          <p:nvPr/>
        </p:nvSpPr>
        <p:spPr>
          <a:xfrm>
            <a:off x="4823844" y="1455053"/>
            <a:ext cx="288032" cy="390364"/>
          </a:xfrm>
          <a:prstGeom prst="downArrow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下矢印 11"/>
          <p:cNvSpPr/>
          <p:nvPr/>
        </p:nvSpPr>
        <p:spPr>
          <a:xfrm>
            <a:off x="5111876" y="1455053"/>
            <a:ext cx="288032" cy="390364"/>
          </a:xfrm>
          <a:prstGeom prst="downArrow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下矢印 12"/>
          <p:cNvSpPr/>
          <p:nvPr/>
        </p:nvSpPr>
        <p:spPr>
          <a:xfrm>
            <a:off x="5399908" y="1455053"/>
            <a:ext cx="288032" cy="390364"/>
          </a:xfrm>
          <a:prstGeom prst="downArrow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2379756" y="847024"/>
            <a:ext cx="1069010" cy="28672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IVI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2403179" y="1505059"/>
            <a:ext cx="2396677" cy="36004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L 0.5 mg/kg</a:t>
            </a:r>
            <a:endPara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5759948" y="1296963"/>
            <a:ext cx="2208261" cy="56813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L  1 mg/kg</a:t>
            </a:r>
            <a:endPara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4746387" y="1112296"/>
            <a:ext cx="11250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mPSL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1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2366255" y="2059512"/>
            <a:ext cx="2339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Romiplostim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1 mg/k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角丸四角形 18"/>
          <p:cNvSpPr/>
          <p:nvPr/>
        </p:nvSpPr>
        <p:spPr>
          <a:xfrm>
            <a:off x="2994074" y="2873211"/>
            <a:ext cx="3389958" cy="360039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" lastClr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Alveolar hemorrhage</a:t>
            </a:r>
            <a:endParaRPr kumimoji="0" lang="ja-JP" altLang="en-US" sz="2000" kern="0" dirty="0">
              <a:solidFill>
                <a:sysClr val="window" lastClr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二等辺三角形 19"/>
          <p:cNvSpPr/>
          <p:nvPr/>
        </p:nvSpPr>
        <p:spPr>
          <a:xfrm rot="10800000">
            <a:off x="2508472" y="2428845"/>
            <a:ext cx="335238" cy="222183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下矢印 20"/>
          <p:cNvSpPr/>
          <p:nvPr/>
        </p:nvSpPr>
        <p:spPr>
          <a:xfrm>
            <a:off x="2297665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下矢印 21"/>
          <p:cNvSpPr/>
          <p:nvPr/>
        </p:nvSpPr>
        <p:spPr>
          <a:xfrm>
            <a:off x="2526458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下矢印 22"/>
          <p:cNvSpPr/>
          <p:nvPr/>
        </p:nvSpPr>
        <p:spPr>
          <a:xfrm>
            <a:off x="3143673" y="280922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下矢印 23"/>
          <p:cNvSpPr/>
          <p:nvPr/>
        </p:nvSpPr>
        <p:spPr>
          <a:xfrm>
            <a:off x="3390554" y="280922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3"/>
          <p:cNvSpPr txBox="1"/>
          <p:nvPr/>
        </p:nvSpPr>
        <p:spPr>
          <a:xfrm>
            <a:off x="2890258" y="-22621"/>
            <a:ext cx="1828899" cy="34122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latelet Transfusion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二等辺三角形 26"/>
          <p:cNvSpPr/>
          <p:nvPr/>
        </p:nvSpPr>
        <p:spPr>
          <a:xfrm rot="5400000">
            <a:off x="8956002" y="476630"/>
            <a:ext cx="568137" cy="2208804"/>
          </a:xfrm>
          <a:prstGeom prst="triangle">
            <a:avLst>
              <a:gd name="adj" fmla="val 100000"/>
            </a:avLst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二等辺三角形 27"/>
          <p:cNvSpPr/>
          <p:nvPr/>
        </p:nvSpPr>
        <p:spPr>
          <a:xfrm rot="10800000">
            <a:off x="3984551" y="2428844"/>
            <a:ext cx="335238" cy="222183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二等辺三角形 28"/>
          <p:cNvSpPr/>
          <p:nvPr/>
        </p:nvSpPr>
        <p:spPr>
          <a:xfrm rot="10800000">
            <a:off x="4895625" y="2416999"/>
            <a:ext cx="335239" cy="406847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4814929" y="2066486"/>
            <a:ext cx="24673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Romiplostim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10 mg/k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二等辺三角形 30"/>
          <p:cNvSpPr/>
          <p:nvPr/>
        </p:nvSpPr>
        <p:spPr>
          <a:xfrm rot="10800000">
            <a:off x="6528838" y="2416998"/>
            <a:ext cx="335239" cy="406847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4770629" y="847024"/>
            <a:ext cx="1069010" cy="28672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IVI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下矢印 32"/>
          <p:cNvSpPr/>
          <p:nvPr/>
        </p:nvSpPr>
        <p:spPr>
          <a:xfrm>
            <a:off x="3647729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下矢印 33"/>
          <p:cNvSpPr/>
          <p:nvPr/>
        </p:nvSpPr>
        <p:spPr>
          <a:xfrm>
            <a:off x="3894610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下矢印 34"/>
          <p:cNvSpPr/>
          <p:nvPr/>
        </p:nvSpPr>
        <p:spPr>
          <a:xfrm>
            <a:off x="4151785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下矢印 35"/>
          <p:cNvSpPr/>
          <p:nvPr/>
        </p:nvSpPr>
        <p:spPr>
          <a:xfrm>
            <a:off x="4398666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下矢印 36"/>
          <p:cNvSpPr/>
          <p:nvPr/>
        </p:nvSpPr>
        <p:spPr>
          <a:xfrm>
            <a:off x="4655841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下矢印 37"/>
          <p:cNvSpPr/>
          <p:nvPr/>
        </p:nvSpPr>
        <p:spPr>
          <a:xfrm>
            <a:off x="4958964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下矢印 38"/>
          <p:cNvSpPr/>
          <p:nvPr/>
        </p:nvSpPr>
        <p:spPr>
          <a:xfrm>
            <a:off x="5231905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下矢印 39"/>
          <p:cNvSpPr/>
          <p:nvPr/>
        </p:nvSpPr>
        <p:spPr>
          <a:xfrm>
            <a:off x="5766818" y="28092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>
                <a:lumMod val="85000"/>
                <a:lumOff val="15000"/>
              </a:schemeClr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1511573" y="-36676"/>
            <a:ext cx="13773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【Case 1】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1"/>
          <p:cNvSpPr txBox="1"/>
          <p:nvPr/>
        </p:nvSpPr>
        <p:spPr>
          <a:xfrm>
            <a:off x="1502604" y="1296963"/>
            <a:ext cx="1209021" cy="67627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Plt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defRPr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/L</a:t>
            </a:r>
            <a:endParaRPr lang="ja-JP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角丸四角形 42"/>
          <p:cNvSpPr/>
          <p:nvPr/>
        </p:nvSpPr>
        <p:spPr>
          <a:xfrm>
            <a:off x="2320648" y="4040408"/>
            <a:ext cx="2206604" cy="396704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iO</a:t>
            </a:r>
            <a:r>
              <a:rPr kumimoji="0" lang="en-US" altLang="ja-JP" sz="2000" kern="0" baseline="-250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40%</a:t>
            </a:r>
            <a:endParaRPr kumimoji="0" lang="ja-JP" altLang="en-US" sz="20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角丸四角形 43"/>
          <p:cNvSpPr/>
          <p:nvPr/>
        </p:nvSpPr>
        <p:spPr>
          <a:xfrm>
            <a:off x="4500742" y="4040408"/>
            <a:ext cx="2028094" cy="396704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70%</a:t>
            </a:r>
            <a:endParaRPr kumimoji="0" lang="ja-JP" altLang="en-US" sz="20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角丸四角形 44"/>
          <p:cNvSpPr/>
          <p:nvPr/>
        </p:nvSpPr>
        <p:spPr>
          <a:xfrm>
            <a:off x="6528836" y="4040408"/>
            <a:ext cx="1223348" cy="396704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40%</a:t>
            </a:r>
            <a:endParaRPr kumimoji="0" lang="ja-JP" altLang="en-US" sz="20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46" name="Picture 2" descr="E:\Users\mint\Desktop\画像Download\20140224\0001\image-0002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31705" y="4995158"/>
            <a:ext cx="2372499" cy="18628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7" name="Picture 2" descr="E:\Users\mint\Desktop\画像Download\20140224\0001\image-000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519937" y="4995158"/>
            <a:ext cx="2371597" cy="18628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8" name="Picture 3" descr="E:\Users\mint\Desktop\画像Download\image-0002.jpg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1342019" y="4995158"/>
            <a:ext cx="2375011" cy="18628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9" name="Picture 2" descr="E:\Users\mint\Desktop\画像Download\image-0004.jpg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8260679" y="4995158"/>
            <a:ext cx="2372821" cy="18628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左中かっこ 1"/>
          <p:cNvSpPr/>
          <p:nvPr/>
        </p:nvSpPr>
        <p:spPr>
          <a:xfrm rot="5400000">
            <a:off x="4514689" y="1775680"/>
            <a:ext cx="432046" cy="6042942"/>
          </a:xfrm>
          <a:prstGeom prst="leftBrace">
            <a:avLst>
              <a:gd name="adj1" fmla="val 8333"/>
              <a:gd name="adj2" fmla="val 85742"/>
            </a:avLst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左中かっこ 49"/>
          <p:cNvSpPr/>
          <p:nvPr/>
        </p:nvSpPr>
        <p:spPr>
          <a:xfrm rot="5400000">
            <a:off x="9180849" y="3646248"/>
            <a:ext cx="576063" cy="2301806"/>
          </a:xfrm>
          <a:prstGeom prst="leftBrace">
            <a:avLst>
              <a:gd name="adj1" fmla="val 8333"/>
              <a:gd name="adj2" fmla="val 29579"/>
            </a:avLst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769412" y="196700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890528" y="2466361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1887869" y="299695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121906" y="334878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角丸四角形 55"/>
          <p:cNvSpPr/>
          <p:nvPr/>
        </p:nvSpPr>
        <p:spPr>
          <a:xfrm>
            <a:off x="7809164" y="4149080"/>
            <a:ext cx="159044" cy="288032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endParaRPr kumimoji="0" lang="ja-JP" altLang="en-US" sz="20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57" name="角丸四角形 56"/>
          <p:cNvSpPr/>
          <p:nvPr/>
        </p:nvSpPr>
        <p:spPr>
          <a:xfrm>
            <a:off x="8006892" y="4238760"/>
            <a:ext cx="135446" cy="198352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endParaRPr kumimoji="0" lang="ja-JP" altLang="en-US" sz="20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58" name="角丸四角形 57"/>
          <p:cNvSpPr/>
          <p:nvPr/>
        </p:nvSpPr>
        <p:spPr>
          <a:xfrm>
            <a:off x="8189202" y="4359347"/>
            <a:ext cx="128775" cy="72008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endParaRPr kumimoji="0" lang="ja-JP" altLang="en-US" sz="20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cxnSp>
        <p:nvCxnSpPr>
          <p:cNvPr id="59" name="直線コネクタ 58"/>
          <p:cNvCxnSpPr/>
          <p:nvPr/>
        </p:nvCxnSpPr>
        <p:spPr>
          <a:xfrm>
            <a:off x="2442181" y="1911072"/>
            <a:ext cx="0" cy="161175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642618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/>
          </p:nvPr>
        </p:nvGraphicFramePr>
        <p:xfrm>
          <a:off x="1674820" y="1722028"/>
          <a:ext cx="8993180" cy="25267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二等辺三角形 8"/>
          <p:cNvSpPr/>
          <p:nvPr/>
        </p:nvSpPr>
        <p:spPr>
          <a:xfrm rot="10800000">
            <a:off x="2546604" y="2029554"/>
            <a:ext cx="385763" cy="41433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lang="ja-JP" altLang="en-US" kern="0">
              <a:solidFill>
                <a:sysClr val="window" lastClr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二等辺三角形 9"/>
          <p:cNvSpPr/>
          <p:nvPr/>
        </p:nvSpPr>
        <p:spPr>
          <a:xfrm rot="10800000">
            <a:off x="3796896" y="2029554"/>
            <a:ext cx="385763" cy="414338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lang="ja-JP" altLang="en-US" kern="0">
              <a:solidFill>
                <a:sysClr val="window" lastClr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7"/>
          <p:cNvSpPr txBox="1"/>
          <p:nvPr/>
        </p:nvSpPr>
        <p:spPr>
          <a:xfrm>
            <a:off x="2718067" y="1612247"/>
            <a:ext cx="2403222" cy="369332"/>
          </a:xfrm>
          <a:prstGeom prst="rect">
            <a:avLst/>
          </a:prstGeom>
          <a:noFill/>
          <a:ln>
            <a:noFill/>
          </a:ln>
          <a:effectLst/>
        </p:spPr>
        <p:txBody>
          <a:bodyPr wrap="none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ja-JP" sz="1800" kern="0" dirty="0" err="1">
                <a:latin typeface="Arial" panose="020B0604020202020204" pitchFamily="34" charset="0"/>
                <a:cs typeface="Arial" panose="020B0604020202020204" pitchFamily="34" charset="0"/>
              </a:rPr>
              <a:t>Romiplostim</a:t>
            </a:r>
            <a:r>
              <a:rPr lang="en-US" altLang="ja-JP" sz="1800" kern="0" dirty="0">
                <a:latin typeface="Arial" panose="020B0604020202020204" pitchFamily="34" charset="0"/>
                <a:cs typeface="Arial" panose="020B0604020202020204" pitchFamily="34" charset="0"/>
              </a:rPr>
              <a:t> 10mg/kg</a:t>
            </a:r>
          </a:p>
        </p:txBody>
      </p:sp>
      <p:sp>
        <p:nvSpPr>
          <p:cNvPr id="12" name="下矢印 11"/>
          <p:cNvSpPr/>
          <p:nvPr/>
        </p:nvSpPr>
        <p:spPr>
          <a:xfrm>
            <a:off x="2354904" y="38071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下矢印 12"/>
          <p:cNvSpPr/>
          <p:nvPr/>
        </p:nvSpPr>
        <p:spPr>
          <a:xfrm>
            <a:off x="2666848" y="38071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下矢印 13"/>
          <p:cNvSpPr/>
          <p:nvPr/>
        </p:nvSpPr>
        <p:spPr>
          <a:xfrm>
            <a:off x="2983555" y="38071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下矢印 14"/>
          <p:cNvSpPr/>
          <p:nvPr/>
        </p:nvSpPr>
        <p:spPr>
          <a:xfrm>
            <a:off x="3338361" y="38071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下矢印 15"/>
          <p:cNvSpPr/>
          <p:nvPr/>
        </p:nvSpPr>
        <p:spPr>
          <a:xfrm>
            <a:off x="4257523" y="380713"/>
            <a:ext cx="254793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下矢印 16"/>
          <p:cNvSpPr/>
          <p:nvPr/>
        </p:nvSpPr>
        <p:spPr>
          <a:xfrm>
            <a:off x="5205259" y="380713"/>
            <a:ext cx="25479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下矢印 17"/>
          <p:cNvSpPr/>
          <p:nvPr/>
        </p:nvSpPr>
        <p:spPr>
          <a:xfrm>
            <a:off x="5563464" y="38071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下矢印 18"/>
          <p:cNvSpPr/>
          <p:nvPr/>
        </p:nvSpPr>
        <p:spPr>
          <a:xfrm>
            <a:off x="4883520" y="380713"/>
            <a:ext cx="254793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下矢印 19"/>
          <p:cNvSpPr/>
          <p:nvPr/>
        </p:nvSpPr>
        <p:spPr>
          <a:xfrm>
            <a:off x="3667096" y="38071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下矢印 20"/>
          <p:cNvSpPr/>
          <p:nvPr/>
        </p:nvSpPr>
        <p:spPr>
          <a:xfrm>
            <a:off x="4573734" y="380713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角丸四角形 21"/>
          <p:cNvSpPr/>
          <p:nvPr/>
        </p:nvSpPr>
        <p:spPr>
          <a:xfrm>
            <a:off x="2402803" y="2662775"/>
            <a:ext cx="3571875" cy="414338"/>
          </a:xfrm>
          <a:prstGeom prst="roundRect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1800" kern="0" dirty="0">
                <a:solidFill>
                  <a:sysClr val="window" lastClr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veolar hemorrhage</a:t>
            </a:r>
            <a:endParaRPr kumimoji="0" lang="ja-JP" altLang="en-US" sz="1800" kern="0" dirty="0">
              <a:solidFill>
                <a:sysClr val="window" lastClr="FFFFFF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3" name="角丸四角形 22"/>
          <p:cNvSpPr/>
          <p:nvPr/>
        </p:nvSpPr>
        <p:spPr>
          <a:xfrm>
            <a:off x="2320648" y="4248822"/>
            <a:ext cx="3027486" cy="396704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iO</a:t>
            </a:r>
            <a:r>
              <a:rPr kumimoji="0" lang="en-US" altLang="ja-JP" sz="2000" kern="0" baseline="-250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40%</a:t>
            </a:r>
            <a:endParaRPr kumimoji="0" lang="ja-JP" altLang="en-US" sz="20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テキスト ボックス 1"/>
          <p:cNvSpPr txBox="1"/>
          <p:nvPr/>
        </p:nvSpPr>
        <p:spPr>
          <a:xfrm>
            <a:off x="1457827" y="1232948"/>
            <a:ext cx="1209021" cy="67627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Plt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defRPr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/L</a:t>
            </a:r>
            <a:endParaRPr lang="ja-JP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3"/>
          <p:cNvSpPr txBox="1"/>
          <p:nvPr/>
        </p:nvSpPr>
        <p:spPr>
          <a:xfrm>
            <a:off x="2657335" y="-27384"/>
            <a:ext cx="1828899" cy="34122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latelet Transfusion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2320648" y="819706"/>
            <a:ext cx="3600451" cy="50975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L 0.5mg/kg</a:t>
            </a:r>
            <a:endPara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/>
          <p:cNvSpPr/>
          <p:nvPr/>
        </p:nvSpPr>
        <p:spPr>
          <a:xfrm>
            <a:off x="5921098" y="1036257"/>
            <a:ext cx="1975103" cy="29320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L tapering</a:t>
            </a:r>
            <a:endPara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2348034" y="1329461"/>
            <a:ext cx="983457" cy="28672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IVI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1511573" y="-27384"/>
            <a:ext cx="13773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【Case 2】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二等辺三角形 31"/>
          <p:cNvSpPr/>
          <p:nvPr/>
        </p:nvSpPr>
        <p:spPr>
          <a:xfrm rot="5400000">
            <a:off x="9009740" y="-77280"/>
            <a:ext cx="293203" cy="2520279"/>
          </a:xfrm>
          <a:prstGeom prst="triangle">
            <a:avLst>
              <a:gd name="adj" fmla="val 100000"/>
            </a:avLst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10" descr="E:\Users\mint\Desktop\画像Download\image-0009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393744" y="4756246"/>
            <a:ext cx="2702256" cy="21017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" name="図 3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32304" y="4645526"/>
            <a:ext cx="1384348" cy="2179247"/>
          </a:xfrm>
          <a:prstGeom prst="rect">
            <a:avLst/>
          </a:prstGeom>
        </p:spPr>
      </p:pic>
      <p:sp>
        <p:nvSpPr>
          <p:cNvPr id="34" name="角丸四角形 33"/>
          <p:cNvSpPr/>
          <p:nvPr/>
        </p:nvSpPr>
        <p:spPr>
          <a:xfrm>
            <a:off x="5397186" y="4355570"/>
            <a:ext cx="159044" cy="288032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endParaRPr kumimoji="0" lang="ja-JP" altLang="en-US" sz="20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6" name="角丸四角形 35"/>
          <p:cNvSpPr/>
          <p:nvPr/>
        </p:nvSpPr>
        <p:spPr>
          <a:xfrm>
            <a:off x="5594914" y="4445250"/>
            <a:ext cx="135446" cy="198352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endParaRPr kumimoji="0" lang="ja-JP" altLang="en-US" sz="20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7" name="角丸四角形 36"/>
          <p:cNvSpPr/>
          <p:nvPr/>
        </p:nvSpPr>
        <p:spPr>
          <a:xfrm>
            <a:off x="5777224" y="4565837"/>
            <a:ext cx="128775" cy="72008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endParaRPr kumimoji="0" lang="ja-JP" altLang="en-US" sz="2000" kern="0" dirty="0">
              <a:solidFill>
                <a:sysClr val="windowText" lastClr="000000"/>
              </a:solidFill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698842" y="1691516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789022" y="2483604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815861" y="3212976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953823" y="353345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コネクタ 41"/>
          <p:cNvCxnSpPr/>
          <p:nvPr/>
        </p:nvCxnSpPr>
        <p:spPr>
          <a:xfrm>
            <a:off x="2357294" y="1659618"/>
            <a:ext cx="0" cy="21569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047148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下矢印 4"/>
          <p:cNvSpPr/>
          <p:nvPr/>
        </p:nvSpPr>
        <p:spPr>
          <a:xfrm>
            <a:off x="2417542" y="1206095"/>
            <a:ext cx="288032" cy="390364"/>
          </a:xfrm>
          <a:prstGeom prst="down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下矢印 5"/>
          <p:cNvSpPr/>
          <p:nvPr/>
        </p:nvSpPr>
        <p:spPr>
          <a:xfrm>
            <a:off x="2713958" y="1206095"/>
            <a:ext cx="288032" cy="390364"/>
          </a:xfrm>
          <a:prstGeom prst="down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下矢印 6"/>
          <p:cNvSpPr/>
          <p:nvPr/>
        </p:nvSpPr>
        <p:spPr>
          <a:xfrm>
            <a:off x="3001990" y="1206095"/>
            <a:ext cx="288032" cy="390364"/>
          </a:xfrm>
          <a:prstGeom prst="down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下矢印 7"/>
          <p:cNvSpPr/>
          <p:nvPr/>
        </p:nvSpPr>
        <p:spPr>
          <a:xfrm>
            <a:off x="3290022" y="1206095"/>
            <a:ext cx="288032" cy="390364"/>
          </a:xfrm>
          <a:prstGeom prst="down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下矢印 8"/>
          <p:cNvSpPr/>
          <p:nvPr/>
        </p:nvSpPr>
        <p:spPr>
          <a:xfrm>
            <a:off x="3578054" y="1206095"/>
            <a:ext cx="288032" cy="390364"/>
          </a:xfrm>
          <a:prstGeom prst="downArrow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グラフ 9"/>
          <p:cNvGraphicFramePr>
            <a:graphicFrameLocks/>
          </p:cNvGraphicFramePr>
          <p:nvPr>
            <p:extLst/>
          </p:nvPr>
        </p:nvGraphicFramePr>
        <p:xfrm>
          <a:off x="1524000" y="1596459"/>
          <a:ext cx="9144000" cy="23029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正方形/長方形 10"/>
          <p:cNvSpPr/>
          <p:nvPr/>
        </p:nvSpPr>
        <p:spPr>
          <a:xfrm>
            <a:off x="2783632" y="1680238"/>
            <a:ext cx="1405528" cy="286727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IVI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3935760" y="1091099"/>
            <a:ext cx="1872208" cy="505361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L 1mg/kg</a:t>
            </a:r>
            <a:endPara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5807968" y="1206095"/>
            <a:ext cx="3312368" cy="390364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L 0.5 mg/kg</a:t>
            </a:r>
            <a:endPara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2495672" y="765700"/>
            <a:ext cx="11250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mPSL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1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2304674" y="1945902"/>
            <a:ext cx="24673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Romiplostim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10 mg/kg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1497210" y="-27384"/>
            <a:ext cx="13773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【Case 3】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角丸四角形 17"/>
          <p:cNvSpPr/>
          <p:nvPr/>
        </p:nvSpPr>
        <p:spPr>
          <a:xfrm>
            <a:off x="2207569" y="2747283"/>
            <a:ext cx="2952328" cy="360039"/>
          </a:xfrm>
          <a:prstGeom prst="roundRect">
            <a:avLst/>
          </a:prstGeom>
          <a:solidFill>
            <a:schemeClr val="bg1">
              <a:lumMod val="50000"/>
            </a:schemeClr>
          </a:solidFill>
          <a:ln w="25400" cap="flat" cmpd="sng" algn="ctr">
            <a:noFill/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" lastClr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veolar hemorrhage</a:t>
            </a:r>
            <a:endParaRPr kumimoji="0" lang="ja-JP" altLang="en-US" sz="2000" kern="0" dirty="0">
              <a:solidFill>
                <a:sysClr val="window" lastClr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二等辺三角形 14"/>
          <p:cNvSpPr/>
          <p:nvPr/>
        </p:nvSpPr>
        <p:spPr>
          <a:xfrm rot="10800000">
            <a:off x="2575855" y="2315234"/>
            <a:ext cx="386426" cy="50405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下矢印 18"/>
          <p:cNvSpPr/>
          <p:nvPr/>
        </p:nvSpPr>
        <p:spPr>
          <a:xfrm>
            <a:off x="2290314" y="380712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下矢印 19"/>
          <p:cNvSpPr/>
          <p:nvPr/>
        </p:nvSpPr>
        <p:spPr>
          <a:xfrm>
            <a:off x="2602258" y="380712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下矢印 20"/>
          <p:cNvSpPr/>
          <p:nvPr/>
        </p:nvSpPr>
        <p:spPr>
          <a:xfrm>
            <a:off x="2918965" y="380712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下矢印 21"/>
          <p:cNvSpPr/>
          <p:nvPr/>
        </p:nvSpPr>
        <p:spPr>
          <a:xfrm>
            <a:off x="3273771" y="380712"/>
            <a:ext cx="257175" cy="371475"/>
          </a:xfrm>
          <a:prstGeom prst="downArrow">
            <a:avLst/>
          </a:prstGeom>
          <a:noFill/>
          <a:ln w="3810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endParaRPr kumimoji="0" lang="ja-JP" altLang="en-US" kern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3"/>
          <p:cNvSpPr txBox="1"/>
          <p:nvPr/>
        </p:nvSpPr>
        <p:spPr>
          <a:xfrm>
            <a:off x="2623895" y="39489"/>
            <a:ext cx="1828899" cy="34122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latelet Transfusion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1"/>
          <p:cNvSpPr txBox="1"/>
          <p:nvPr/>
        </p:nvSpPr>
        <p:spPr>
          <a:xfrm>
            <a:off x="1497211" y="997767"/>
            <a:ext cx="1105047" cy="598692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Plt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defRPr/>
            </a:pP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×10</a:t>
            </a:r>
            <a:r>
              <a:rPr lang="en-US" altLang="ja-JP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/L</a:t>
            </a:r>
            <a:endParaRPr lang="ja-JP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二等辺三角形 30"/>
          <p:cNvSpPr/>
          <p:nvPr/>
        </p:nvSpPr>
        <p:spPr>
          <a:xfrm rot="5400000">
            <a:off x="9537222" y="789212"/>
            <a:ext cx="390365" cy="1224136"/>
          </a:xfrm>
          <a:prstGeom prst="triangle">
            <a:avLst>
              <a:gd name="adj" fmla="val 100000"/>
            </a:avLst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角丸四角形 31"/>
          <p:cNvSpPr/>
          <p:nvPr/>
        </p:nvSpPr>
        <p:spPr>
          <a:xfrm>
            <a:off x="2107420" y="3862745"/>
            <a:ext cx="1378976" cy="396704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iO</a:t>
            </a:r>
            <a:r>
              <a:rPr kumimoji="0" lang="en-US" altLang="ja-JP" sz="2000" kern="0" baseline="-2500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80%</a:t>
            </a:r>
            <a:endParaRPr kumimoji="0" lang="ja-JP" altLang="en-US" sz="20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角丸四角形 32"/>
          <p:cNvSpPr/>
          <p:nvPr/>
        </p:nvSpPr>
        <p:spPr>
          <a:xfrm>
            <a:off x="3486396" y="3862745"/>
            <a:ext cx="1673500" cy="396704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100%</a:t>
            </a:r>
            <a:endParaRPr kumimoji="0" lang="ja-JP" altLang="en-US" sz="20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角丸四角形 33"/>
          <p:cNvSpPr/>
          <p:nvPr/>
        </p:nvSpPr>
        <p:spPr>
          <a:xfrm>
            <a:off x="5159897" y="3851999"/>
            <a:ext cx="936104" cy="396704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80%</a:t>
            </a:r>
            <a:endParaRPr kumimoji="0" lang="ja-JP" altLang="en-US" sz="20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角丸四角形 34"/>
          <p:cNvSpPr/>
          <p:nvPr/>
        </p:nvSpPr>
        <p:spPr>
          <a:xfrm>
            <a:off x="6096001" y="3862745"/>
            <a:ext cx="2160239" cy="396704"/>
          </a:xfrm>
          <a:prstGeom prst="roundRect">
            <a:avLst/>
          </a:prstGeom>
          <a:noFill/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kumimoji="0" lang="en-US" altLang="ja-JP" sz="20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40%</a:t>
            </a:r>
            <a:endParaRPr kumimoji="0" lang="ja-JP" altLang="en-US" sz="20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図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3482" y="4694035"/>
            <a:ext cx="2054654" cy="2163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図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9160" y="4694034"/>
            <a:ext cx="2050856" cy="21599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左中かっこ 35"/>
          <p:cNvSpPr/>
          <p:nvPr/>
        </p:nvSpPr>
        <p:spPr>
          <a:xfrm rot="5400000">
            <a:off x="3957695" y="2442823"/>
            <a:ext cx="432046" cy="4132596"/>
          </a:xfrm>
          <a:prstGeom prst="leftBrace">
            <a:avLst>
              <a:gd name="adj1" fmla="val 8333"/>
              <a:gd name="adj2" fmla="val 91402"/>
            </a:avLst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8" name="図 1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58947" y="4635536"/>
            <a:ext cx="2106400" cy="22184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左中かっこ 36"/>
          <p:cNvSpPr/>
          <p:nvPr/>
        </p:nvSpPr>
        <p:spPr>
          <a:xfrm rot="5400000">
            <a:off x="9018236" y="3288077"/>
            <a:ext cx="576063" cy="2301806"/>
          </a:xfrm>
          <a:prstGeom prst="leftBrace">
            <a:avLst>
              <a:gd name="adj1" fmla="val 8333"/>
              <a:gd name="adj2" fmla="val 29579"/>
            </a:avLst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509892" y="159763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509892" y="2554331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709281" y="310732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コネクタ 2"/>
          <p:cNvCxnSpPr/>
          <p:nvPr/>
        </p:nvCxnSpPr>
        <p:spPr>
          <a:xfrm>
            <a:off x="2107420" y="1680237"/>
            <a:ext cx="0" cy="161175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65556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Microsoft Office PowerPoint</Application>
  <PresentationFormat>ワイド画面</PresentationFormat>
  <Paragraphs>5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gaharu keiki</dc:creator>
  <cp:lastModifiedBy>nagaharu keiki</cp:lastModifiedBy>
  <cp:revision>1</cp:revision>
  <dcterms:created xsi:type="dcterms:W3CDTF">2019-05-22T13:05:47Z</dcterms:created>
  <dcterms:modified xsi:type="dcterms:W3CDTF">2019-05-22T13:06:12Z</dcterms:modified>
</cp:coreProperties>
</file>